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90" r:id="rId2"/>
    <p:sldId id="291" r:id="rId3"/>
    <p:sldId id="292" r:id="rId4"/>
    <p:sldId id="293" r:id="rId5"/>
    <p:sldId id="294" r:id="rId6"/>
    <p:sldId id="295" r:id="rId7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6pPr>
    <a:lvl7pPr marL="2743200" algn="l" defTabSz="914400" rtl="0" eaLnBrk="1" latinLnBrk="0" hangingPunct="1"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7pPr>
    <a:lvl8pPr marL="3200400" algn="l" defTabSz="914400" rtl="0" eaLnBrk="1" latinLnBrk="0" hangingPunct="1"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8pPr>
    <a:lvl9pPr marL="3657600" algn="l" defTabSz="914400" rtl="0" eaLnBrk="1" latinLnBrk="0" hangingPunct="1">
      <a:defRPr sz="1200" b="1"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5" userDrawn="1">
          <p15:clr>
            <a:srgbClr val="A4A3A4"/>
          </p15:clr>
        </p15:guide>
        <p15:guide id="2" pos="14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ng Zhang" initials="YZ" lastIdx="8" clrIdx="0">
    <p:extLst>
      <p:ext uri="{19B8F6BF-5375-455C-9EA6-DF929625EA0E}">
        <p15:presenceInfo xmlns:p15="http://schemas.microsoft.com/office/powerpoint/2012/main" userId="S-1-5-21-646036717-1379592481-1600295466-4287" providerId="AD"/>
      </p:ext>
    </p:extLst>
  </p:cmAuthor>
  <p:cmAuthor id="2" name="Bo Li" initials="BL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70" autoAdjust="0"/>
    <p:restoredTop sz="94660"/>
  </p:normalViewPr>
  <p:slideViewPr>
    <p:cSldViewPr>
      <p:cViewPr varScale="1">
        <p:scale>
          <a:sx n="45" d="100"/>
          <a:sy n="45" d="100"/>
        </p:scale>
        <p:origin x="2223" y="36"/>
      </p:cViewPr>
      <p:guideLst>
        <p:guide orient="horz" pos="385"/>
        <p:guide pos="14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5" cy="36004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image" Target="../media/image17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image" Target="../media/image2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b="0"/>
            </a:lvl1pPr>
          </a:lstStyle>
          <a:p>
            <a:endParaRPr lang="en-US" altLang="zh-CN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b="0"/>
            </a:lvl1pPr>
          </a:lstStyle>
          <a:p>
            <a:endParaRPr lang="en-US" altLang="zh-CN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43125" y="685800"/>
            <a:ext cx="257175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  <a:endParaRPr lang="en-US" altLang="zh-CN"/>
          </a:p>
          <a:p>
            <a:pPr lvl="1"/>
            <a:r>
              <a:rPr lang="zh-CN" altLang="en-US"/>
              <a:t>第二级</a:t>
            </a:r>
            <a:endParaRPr lang="en-US" altLang="zh-CN"/>
          </a:p>
          <a:p>
            <a:pPr lvl="2"/>
            <a:r>
              <a:rPr lang="zh-CN" altLang="en-US"/>
              <a:t>第三级</a:t>
            </a:r>
            <a:endParaRPr lang="en-US" altLang="zh-CN"/>
          </a:p>
          <a:p>
            <a:pPr lvl="3"/>
            <a:r>
              <a:rPr lang="zh-CN" altLang="en-US"/>
              <a:t>第四级</a:t>
            </a:r>
            <a:endParaRPr lang="en-US" altLang="zh-CN"/>
          </a:p>
          <a:p>
            <a:pPr lvl="4"/>
            <a:r>
              <a:rPr lang="zh-CN" altLang="en-US"/>
              <a:t>第五级</a:t>
            </a:r>
            <a:endParaRPr lang="en-US" altLang="zh-CN"/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b="0"/>
            </a:lvl1pPr>
          </a:lstStyle>
          <a:p>
            <a:endParaRPr lang="en-US" altLang="zh-CN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b="0"/>
            </a:lvl1pPr>
          </a:lstStyle>
          <a:p>
            <a:fld id="{98FB5A3F-25F4-450E-B36F-FE072A5517C1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98983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0"/>
        <a:cs typeface="宋体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0"/>
        <a:cs typeface="宋体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0"/>
        <a:cs typeface="宋体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0"/>
        <a:cs typeface="宋体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0"/>
        <a:cs typeface="宋体" charset="0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E94BAC8-EEEA-4635-9173-08BFFE65A55A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48F5F05-EEA5-4D75-9DDF-084F1B66A819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E317A12-8DB0-4654-A4EA-06244774A1A3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1E4462C-9D98-472B-ADD6-EAF0622F0BAC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181199F-3BB9-42B9-8E57-040F3D1C999B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27C469D-5D38-4447-B2F3-D2B142A213FE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5BE20A1-F612-4344-93E3-379B89D0399C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FCD135E-040B-43A9-8A31-66AC8E1FB879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83840BF-1172-40A4-A2C2-0168A16C70B3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900E0D7-282A-4227-B584-1D3050CB82DA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56553D0-C48A-4498-9C32-7E3B97D37BDE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322F320-0B67-47D2-B8FC-F9C6654DED62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  <a:endParaRPr lang="en-US" altLang="zh-CN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  <a:endParaRPr lang="en-US" altLang="zh-CN"/>
          </a:p>
          <a:p>
            <a:pPr lvl="1"/>
            <a:r>
              <a:rPr lang="zh-CN" altLang="en-US"/>
              <a:t>第二级</a:t>
            </a:r>
            <a:endParaRPr lang="en-US" altLang="zh-CN"/>
          </a:p>
          <a:p>
            <a:pPr lvl="2"/>
            <a:r>
              <a:rPr lang="zh-CN" altLang="en-US"/>
              <a:t>第三级</a:t>
            </a:r>
            <a:endParaRPr lang="en-US" altLang="zh-CN"/>
          </a:p>
          <a:p>
            <a:pPr lvl="3"/>
            <a:r>
              <a:rPr lang="zh-CN" altLang="en-US"/>
              <a:t>第四级</a:t>
            </a:r>
            <a:endParaRPr lang="en-US" altLang="zh-CN"/>
          </a:p>
          <a:p>
            <a:pPr lvl="4"/>
            <a:r>
              <a:rPr lang="zh-CN" altLang="en-US"/>
              <a:t>第五级</a:t>
            </a:r>
            <a:endParaRPr lang="en-US" altLang="zh-CN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/>
            </a:lvl1pPr>
          </a:lstStyle>
          <a:p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/>
            </a:lvl1pPr>
          </a:lstStyle>
          <a:p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/>
            </a:lvl1pPr>
          </a:lstStyle>
          <a:p>
            <a:fld id="{0E4B17FA-7F51-4EB2-AE1C-C4BDBC2C019A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oleObject" Target="../embeddings/oleObject3.bin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12" Type="http://schemas.openxmlformats.org/officeDocument/2006/relationships/image" Target="../media/image17.emf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2.vml"/><Relationship Id="rId6" Type="http://schemas.microsoft.com/office/2007/relationships/hdphoto" Target="../media/hdphoto2.wdp"/><Relationship Id="rId11" Type="http://schemas.openxmlformats.org/officeDocument/2006/relationships/oleObject" Target="../embeddings/oleObject2.bin"/><Relationship Id="rId5" Type="http://schemas.openxmlformats.org/officeDocument/2006/relationships/image" Target="../media/image20.png"/><Relationship Id="rId10" Type="http://schemas.openxmlformats.org/officeDocument/2006/relationships/image" Target="../media/image24.png"/><Relationship Id="rId4" Type="http://schemas.microsoft.com/office/2007/relationships/hdphoto" Target="../media/hdphoto1.wdp"/><Relationship Id="rId9" Type="http://schemas.openxmlformats.org/officeDocument/2006/relationships/image" Target="../media/image23.png"/><Relationship Id="rId14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5080" y="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Fig </a:t>
            </a: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S1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2646" y="306691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408529" y="391363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619206" y="420800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C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484337" y="2636303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648643" y="2619369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F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1661" y="4639736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51215" y="2610902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D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92804" y="4594436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H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66797" y="442168"/>
            <a:ext cx="2011680" cy="19470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704874" y="425231"/>
            <a:ext cx="2011680" cy="19599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 rotWithShape="1">
          <a:blip r:embed="rId4"/>
          <a:srcRect r="7531"/>
          <a:stretch/>
        </p:blipFill>
        <p:spPr bwMode="auto">
          <a:xfrm>
            <a:off x="4863254" y="403866"/>
            <a:ext cx="1860174" cy="20042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04701" y="2664000"/>
            <a:ext cx="2011680" cy="19599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8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59422" y="5224220"/>
            <a:ext cx="2011680" cy="20541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9" name="Picture 7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826988" y="5224221"/>
            <a:ext cx="2011680" cy="20541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00" name="Picture 8"/>
          <p:cNvPicPr>
            <a:picLocks noChangeAspect="1" noChangeArrowheads="1"/>
          </p:cNvPicPr>
          <p:nvPr/>
        </p:nvPicPr>
        <p:blipFill rotWithShape="1">
          <a:blip r:embed="rId8"/>
          <a:srcRect r="7531"/>
          <a:stretch/>
        </p:blipFill>
        <p:spPr bwMode="auto">
          <a:xfrm>
            <a:off x="2759032" y="2664000"/>
            <a:ext cx="1860174" cy="20042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01" name="Picture 9"/>
          <p:cNvPicPr>
            <a:picLocks noChangeAspect="1" noChangeArrowheads="1"/>
          </p:cNvPicPr>
          <p:nvPr/>
        </p:nvPicPr>
        <p:blipFill rotWithShape="1">
          <a:blip r:embed="rId9"/>
          <a:srcRect r="7531"/>
          <a:stretch/>
        </p:blipFill>
        <p:spPr bwMode="auto">
          <a:xfrm>
            <a:off x="4961857" y="2664000"/>
            <a:ext cx="1860174" cy="20264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5080" y="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Fig S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646" y="408295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315002" y="450435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474872" y="463135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C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6203" y="853012"/>
            <a:ext cx="2194560" cy="21945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442002" y="869947"/>
            <a:ext cx="2011680" cy="20988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2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767576" y="763911"/>
            <a:ext cx="2011680" cy="2182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5080" y="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Fig S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646" y="306691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221361" y="369998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8595" y="755839"/>
            <a:ext cx="2926080" cy="2709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530604" y="704642"/>
            <a:ext cx="2926080" cy="27233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5080" y="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Fig S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646" y="486844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708910" y="520714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9255" y="3256438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C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6894" y="833993"/>
            <a:ext cx="2468880" cy="1937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429000" y="838029"/>
            <a:ext cx="2468880" cy="18586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85B95172-A2BE-4EB3-8835-8848A28C8F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2619914"/>
              </p:ext>
            </p:extLst>
          </p:nvPr>
        </p:nvGraphicFramePr>
        <p:xfrm>
          <a:off x="529635" y="3131820"/>
          <a:ext cx="3697605" cy="2673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8" r:id="rId5" imgW="4514338" imgH="3264423" progId="Prism8.Document">
                  <p:embed/>
                </p:oleObj>
              </mc:Choice>
              <mc:Fallback>
                <p:oleObj name="Prism 8" r:id="rId5" imgW="4514338" imgH="32644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9635" y="3131820"/>
                        <a:ext cx="3697605" cy="2673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5080" y="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Fig S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646" y="306691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348865" y="276861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199892" y="276861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C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331931" y="2725404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357" y="2720973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D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458332" y="785276"/>
            <a:ext cx="18002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   </a:t>
            </a:r>
            <a:r>
              <a:rPr lang="en-US" sz="1000" dirty="0" err="1"/>
              <a:t>Dex</a:t>
            </a:r>
            <a:r>
              <a:rPr lang="en-US" sz="1000" dirty="0"/>
              <a:t>   Con  </a:t>
            </a:r>
            <a:r>
              <a:rPr lang="en-US" sz="1000" dirty="0" err="1"/>
              <a:t>Dex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509128" y="1933147"/>
            <a:ext cx="18002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  -         -        +        +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415985" y="2127882"/>
            <a:ext cx="2109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Periostin</a:t>
            </a:r>
            <a:r>
              <a:rPr lang="en-US" sz="800" dirty="0"/>
              <a:t> </a:t>
            </a:r>
            <a:r>
              <a:rPr lang="en-US" sz="800" dirty="0" err="1"/>
              <a:t>Neutrolizing</a:t>
            </a:r>
            <a:r>
              <a:rPr lang="en-US" sz="800" dirty="0"/>
              <a:t> Antibody</a:t>
            </a:r>
          </a:p>
        </p:txBody>
      </p:sp>
      <p:pic>
        <p:nvPicPr>
          <p:cNvPr id="27" name="图片 14">
            <a:extLst>
              <a:ext uri="{FF2B5EF4-FFF2-40B4-BE49-F238E27FC236}">
                <a16:creationId xmlns:a16="http://schemas.microsoft.com/office/drawing/2014/main" id="{A98ECDF3-CDBB-4151-9E0D-CC561CBC0DC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133" t="48674" r="15829" b="45428"/>
          <a:stretch/>
        </p:blipFill>
        <p:spPr>
          <a:xfrm>
            <a:off x="4492201" y="1556168"/>
            <a:ext cx="1463040" cy="35661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8" name="图片 19">
            <a:extLst>
              <a:ext uri="{FF2B5EF4-FFF2-40B4-BE49-F238E27FC236}">
                <a16:creationId xmlns:a16="http://schemas.microsoft.com/office/drawing/2014/main" id="{CC18A1AE-3130-4EBF-8080-3D7DC97DF49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988" t="57843" r="30140" b="30415"/>
          <a:stretch/>
        </p:blipFill>
        <p:spPr>
          <a:xfrm>
            <a:off x="4483734" y="1094519"/>
            <a:ext cx="1463040" cy="35661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27005" y="713109"/>
            <a:ext cx="2103120" cy="18146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272662" y="509901"/>
            <a:ext cx="2103120" cy="20462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292" name="Picture 4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201098" y="3013282"/>
            <a:ext cx="2103120" cy="20462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293" name="Picture 5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2408134" y="3020488"/>
            <a:ext cx="2103120" cy="20462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" name="文本框 5">
            <a:extLst>
              <a:ext uri="{FF2B5EF4-FFF2-40B4-BE49-F238E27FC236}">
                <a16:creationId xmlns:a16="http://schemas.microsoft.com/office/drawing/2014/main" id="{5BD6E19C-318B-4F37-A885-7945EE85417F}"/>
              </a:ext>
            </a:extLst>
          </p:cNvPr>
          <p:cNvSpPr txBox="1"/>
          <p:nvPr/>
        </p:nvSpPr>
        <p:spPr>
          <a:xfrm>
            <a:off x="5983523" y="1145320"/>
            <a:ext cx="6222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0" dirty="0" err="1"/>
              <a:t>PPAR</a:t>
            </a:r>
            <a:r>
              <a:rPr lang="en-US" altLang="zh-CN" sz="1000" b="0" dirty="0" err="1">
                <a:latin typeface="Symbol" panose="05050102010706020507" pitchFamily="18" charset="2"/>
              </a:rPr>
              <a:t>a</a:t>
            </a:r>
            <a:endParaRPr lang="zh-CN" altLang="en-US" sz="1000" b="0" dirty="0">
              <a:latin typeface="Symbol" panose="05050102010706020507" pitchFamily="18" charset="2"/>
            </a:endParaRPr>
          </a:p>
        </p:txBody>
      </p:sp>
      <p:sp>
        <p:nvSpPr>
          <p:cNvPr id="26" name="文本框 6">
            <a:extLst>
              <a:ext uri="{FF2B5EF4-FFF2-40B4-BE49-F238E27FC236}">
                <a16:creationId xmlns:a16="http://schemas.microsoft.com/office/drawing/2014/main" id="{1F87157D-DFD1-4275-A086-083DD646E095}"/>
              </a:ext>
            </a:extLst>
          </p:cNvPr>
          <p:cNvSpPr txBox="1"/>
          <p:nvPr/>
        </p:nvSpPr>
        <p:spPr>
          <a:xfrm>
            <a:off x="6012400" y="1646598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0" dirty="0">
                <a:latin typeface="Symbol" panose="05050102010706020507" pitchFamily="18" charset="2"/>
              </a:rPr>
              <a:t>b</a:t>
            </a:r>
            <a:r>
              <a:rPr lang="en-US" altLang="zh-CN" sz="1000" b="0" dirty="0"/>
              <a:t> actin</a:t>
            </a:r>
            <a:endParaRPr lang="zh-CN" altLang="en-US" sz="1000" b="0" dirty="0"/>
          </a:p>
        </p:txBody>
      </p:sp>
      <p:sp>
        <p:nvSpPr>
          <p:cNvPr id="29" name="TextBox 22">
            <a:extLst>
              <a:ext uri="{FF2B5EF4-FFF2-40B4-BE49-F238E27FC236}">
                <a16:creationId xmlns:a16="http://schemas.microsoft.com/office/drawing/2014/main" id="{0AC49A78-27DC-4B1E-9426-592D9FF51E06}"/>
              </a:ext>
            </a:extLst>
          </p:cNvPr>
          <p:cNvSpPr txBox="1"/>
          <p:nvPr/>
        </p:nvSpPr>
        <p:spPr>
          <a:xfrm>
            <a:off x="4250552" y="2711648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D33E12C3-4485-4DD7-80CD-47EA2C86EE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2111108"/>
              </p:ext>
            </p:extLst>
          </p:nvPr>
        </p:nvGraphicFramePr>
        <p:xfrm>
          <a:off x="4516904" y="2871584"/>
          <a:ext cx="2559062" cy="21940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Prism 8" r:id="rId11" imgW="3226943" imgH="2767631" progId="Prism8.Document">
                  <p:embed/>
                </p:oleObj>
              </mc:Choice>
              <mc:Fallback>
                <p:oleObj name="Prism 8" r:id="rId11" imgW="3226943" imgH="276763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16904" y="2871584"/>
                        <a:ext cx="2559062" cy="21940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1">
            <a:extLst>
              <a:ext uri="{FF2B5EF4-FFF2-40B4-BE49-F238E27FC236}">
                <a16:creationId xmlns:a16="http://schemas.microsoft.com/office/drawing/2014/main" id="{6CBA7EAC-9320-4BA6-BD80-2E79E14AFE6C}"/>
              </a:ext>
            </a:extLst>
          </p:cNvPr>
          <p:cNvSpPr txBox="1"/>
          <p:nvPr/>
        </p:nvSpPr>
        <p:spPr>
          <a:xfrm>
            <a:off x="25407" y="5049083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E4A910EA-C302-43A6-8ABB-34D6F68F8F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4908905"/>
              </p:ext>
            </p:extLst>
          </p:nvPr>
        </p:nvGraphicFramePr>
        <p:xfrm>
          <a:off x="160917" y="5441946"/>
          <a:ext cx="2245102" cy="2193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8" r:id="rId13" imgW="3036552" imgH="2967068" progId="Prism8.Document">
                  <p:embed/>
                </p:oleObj>
              </mc:Choice>
              <mc:Fallback>
                <p:oleObj name="Prism 8" r:id="rId13" imgW="3036552" imgH="296706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0917" y="5441946"/>
                        <a:ext cx="2245102" cy="2193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5080" y="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Fig S6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34611" y="486844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335200" y="520714"/>
            <a:ext cx="68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6FB65007-68A7-4540-8B32-E3839D9930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5421529"/>
              </p:ext>
            </p:extLst>
          </p:nvPr>
        </p:nvGraphicFramePr>
        <p:xfrm>
          <a:off x="500560" y="880342"/>
          <a:ext cx="2587625" cy="2608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" name="Prism 8" r:id="rId3" imgW="2587025" imgH="2608874" progId="Prism8.Document">
                  <p:embed/>
                </p:oleObj>
              </mc:Choice>
              <mc:Fallback>
                <p:oleObj name="Prism 8" r:id="rId3" imgW="2587025" imgH="26088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0560" y="880342"/>
                        <a:ext cx="2587625" cy="2608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44270334-8026-4D13-954C-749962EF75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2527500"/>
              </p:ext>
            </p:extLst>
          </p:nvPr>
        </p:nvGraphicFramePr>
        <p:xfrm>
          <a:off x="3723323" y="868912"/>
          <a:ext cx="2586037" cy="2608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Prism 8" r:id="rId5" imgW="2585586" imgH="2608874" progId="Prism8.Document">
                  <p:embed/>
                </p:oleObj>
              </mc:Choice>
              <mc:Fallback>
                <p:oleObj name="Prism 8" r:id="rId5" imgW="2585586" imgH="26088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23323" y="868912"/>
                        <a:ext cx="2586037" cy="2608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54450195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宋体"/>
      </a:majorFont>
      <a:minorFont>
        <a:latin typeface="Arial"/>
        <a:ea typeface="宋体"/>
        <a:cs typeface="宋体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5921" dir="2700000" algn="ctr" rotWithShape="0">
                  <a:srgbClr val="808080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2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宋体" charset="0"/>
            <a:cs typeface="宋体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5921" dir="2700000" algn="ctr" rotWithShape="0">
                  <a:srgbClr val="808080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2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宋体" charset="0"/>
            <a:cs typeface="宋体" charset="0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Words>52</Words>
  <Application>Microsoft Office PowerPoint</Application>
  <PresentationFormat>全屏显示(4:3)</PresentationFormat>
  <Paragraphs>36</Paragraphs>
  <Slides>6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Arial</vt:lpstr>
      <vt:lpstr>Symbol</vt:lpstr>
      <vt:lpstr>默认设计模板</vt:lpstr>
      <vt:lpstr>Prism 8</vt:lpstr>
      <vt:lpstr>GraphPad Prism 8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 Li</dc:creator>
  <cp:lastModifiedBy>70139522@qq.com</cp:lastModifiedBy>
  <cp:revision>1145</cp:revision>
  <cp:lastPrinted>1601-01-01T00:00:00Z</cp:lastPrinted>
  <dcterms:created xsi:type="dcterms:W3CDTF">1601-01-01T00:00:00Z</dcterms:created>
  <dcterms:modified xsi:type="dcterms:W3CDTF">2019-10-20T15:05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